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28F91D-8B0E-4B82-AC13-D5B2DA5918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F46E1F-59AC-4423-B5C8-848702FEAE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FFF58D-3726-4737-B9F0-6C33FB013EE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7B29F4-5DF5-44A9-A623-18EA5093A0A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C502E2-A0DF-465B-86F9-7CB1963AAE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1E8E17-330D-450D-A71B-E420390AF2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A593AF-543B-42FD-975E-AD2BC3D98E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DC159C-0A99-4D69-9A5D-5A80A62860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ED85B2-632E-4EA1-8C46-F20159DD25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3C0F8E-018E-414F-9CC4-82DD32B4D7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F8AF12-57F4-49E8-9597-48617511F3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BBA99E-1E39-41DC-B8F9-31DBBE0073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6933311-2945-4DB0-9261-4DD47E2127F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15"/>
          <p:cNvGrpSpPr/>
          <p:nvPr/>
        </p:nvGrpSpPr>
        <p:grpSpPr>
          <a:xfrm>
            <a:off x="692280" y="344520"/>
            <a:ext cx="4095720" cy="5086080"/>
            <a:chOff x="692280" y="344520"/>
            <a:chExt cx="4095720" cy="5086080"/>
          </a:xfrm>
        </p:grpSpPr>
        <p:pic>
          <p:nvPicPr>
            <p:cNvPr id="42" name="Picture 8" descr="C:\Users\Fan\Desktop\H471旱病\转录数据分析\Cluster\all gene without zero 1.jpg"/>
            <p:cNvPicPr/>
            <p:nvPr/>
          </p:nvPicPr>
          <p:blipFill>
            <a:blip r:embed="rId1"/>
            <a:stretch/>
          </p:blipFill>
          <p:spPr>
            <a:xfrm>
              <a:off x="692280" y="344520"/>
              <a:ext cx="3659400" cy="4150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6" descr="C:\Users\Fan\Desktop\H471旱病\转录数据分析\Cluster\all gene without zero_colorbar.jpg"/>
            <p:cNvPicPr/>
            <p:nvPr/>
          </p:nvPicPr>
          <p:blipFill>
            <a:blip r:embed="rId2"/>
            <a:stretch/>
          </p:blipFill>
          <p:spPr>
            <a:xfrm>
              <a:off x="4373640" y="3872160"/>
              <a:ext cx="414360" cy="660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Box 9"/>
            <p:cNvSpPr/>
            <p:nvPr/>
          </p:nvSpPr>
          <p:spPr>
            <a:xfrm rot="16200000">
              <a:off x="1625400" y="4778640"/>
              <a:ext cx="842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HHZ_ck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Box 10"/>
            <p:cNvSpPr/>
            <p:nvPr/>
          </p:nvSpPr>
          <p:spPr>
            <a:xfrm rot="16200000">
              <a:off x="1860120" y="4785840"/>
              <a:ext cx="903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H471_ck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Box 11"/>
            <p:cNvSpPr/>
            <p:nvPr/>
          </p:nvSpPr>
          <p:spPr>
            <a:xfrm rot="16200000">
              <a:off x="2172960" y="4744080"/>
              <a:ext cx="794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28_ck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Box 12"/>
            <p:cNvSpPr/>
            <p:nvPr/>
          </p:nvSpPr>
          <p:spPr>
            <a:xfrm rot="16200000">
              <a:off x="2383920" y="4811760"/>
              <a:ext cx="912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H471_1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Box 13"/>
            <p:cNvSpPr/>
            <p:nvPr/>
          </p:nvSpPr>
          <p:spPr>
            <a:xfrm rot="16200000">
              <a:off x="2673360" y="4795200"/>
              <a:ext cx="851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HHZ_1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Box 14"/>
            <p:cNvSpPr/>
            <p:nvPr/>
          </p:nvSpPr>
          <p:spPr>
            <a:xfrm rot="16200000">
              <a:off x="2960640" y="4769640"/>
              <a:ext cx="803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28_1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Box 15"/>
            <p:cNvSpPr/>
            <p:nvPr/>
          </p:nvSpPr>
          <p:spPr>
            <a:xfrm rot="16200000">
              <a:off x="3171600" y="4820760"/>
              <a:ext cx="912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H471_3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16"/>
            <p:cNvSpPr/>
            <p:nvPr/>
          </p:nvSpPr>
          <p:spPr>
            <a:xfrm rot="16200000">
              <a:off x="3463920" y="4807440"/>
              <a:ext cx="851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HHZ_3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17"/>
            <p:cNvSpPr/>
            <p:nvPr/>
          </p:nvSpPr>
          <p:spPr>
            <a:xfrm rot="16200000">
              <a:off x="3754440" y="4769640"/>
              <a:ext cx="803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28_3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3" name="Text Box 18"/>
          <p:cNvSpPr/>
          <p:nvPr/>
        </p:nvSpPr>
        <p:spPr>
          <a:xfrm>
            <a:off x="5076720" y="1125360"/>
            <a:ext cx="3708360" cy="393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1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.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Hierarchical cluster analysis of nine sample pools (columns) and all expressed genes under control and drought stress conditions (rows). The raw data represented here can be obtained from GEO: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SE57950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. In the color panels, each horizontal line represents a single gene and the color of the line indicates the expression level (in a log scale) of the gene relative to the median in a specific sample: high expression in red, low expression in green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4-08T01:47:37Z</dcterms:created>
  <dc:creator>Binying Fu</dc:creator>
  <dc:description/>
  <dc:language>en-US</dc:language>
  <cp:lastModifiedBy>Lenovo User</cp:lastModifiedBy>
  <dcterms:modified xsi:type="dcterms:W3CDTF">2014-08-26T08:14:26Z</dcterms:modified>
  <cp:revision>10</cp:revision>
  <dc:subject/>
  <dc:title>幻灯片 1</dc:title>
</cp:coreProperties>
</file>